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media/image2.jpg" ContentType="image/tiff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92" autoAdjust="0"/>
    <p:restoredTop sz="94660"/>
  </p:normalViewPr>
  <p:slideViewPr>
    <p:cSldViewPr snapToGrid="0">
      <p:cViewPr varScale="1">
        <p:scale>
          <a:sx n="69" d="100"/>
          <a:sy n="69" d="100"/>
        </p:scale>
        <p:origin x="984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2140781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4665304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10868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569936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3543857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009475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86695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8579697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176524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648676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1069637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40F4CC-9562-4715-9160-4F765CAAD0DE}" type="datetimeFigureOut">
              <a:rPr lang="de-AT" smtClean="0"/>
              <a:t>30.01.2022</a:t>
            </a:fld>
            <a:endParaRPr lang="de-A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249331-9544-475A-A302-C74486674149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7677719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Grafik 8">
            <a:extLst>
              <a:ext uri="{FF2B5EF4-FFF2-40B4-BE49-F238E27FC236}">
                <a16:creationId xmlns:a16="http://schemas.microsoft.com/office/drawing/2014/main" id="{4358D5A3-F461-4499-80F1-1FE5FCE88BB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2984" y="5040352"/>
            <a:ext cx="4919531" cy="5563665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DDA11F00-7FC5-4608-A475-DF33A9965C6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5465" y="1524225"/>
            <a:ext cx="3534568" cy="3516127"/>
          </a:xfrm>
          <a:prstGeom prst="rect">
            <a:avLst/>
          </a:prstGeom>
        </p:spPr>
      </p:pic>
      <p:sp>
        <p:nvSpPr>
          <p:cNvPr id="10" name="Textfeld 9">
            <a:extLst>
              <a:ext uri="{FF2B5EF4-FFF2-40B4-BE49-F238E27FC236}">
                <a16:creationId xmlns:a16="http://schemas.microsoft.com/office/drawing/2014/main" id="{E6CF27C7-0B38-43AC-8BB6-5A8BE986785E}"/>
              </a:ext>
            </a:extLst>
          </p:cNvPr>
          <p:cNvSpPr txBox="1"/>
          <p:nvPr/>
        </p:nvSpPr>
        <p:spPr>
          <a:xfrm>
            <a:off x="568712" y="622833"/>
            <a:ext cx="10727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de-AT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4D94E2A4-EDF7-45C6-92BC-D54892AEB661}"/>
              </a:ext>
            </a:extLst>
          </p:cNvPr>
          <p:cNvSpPr txBox="1"/>
          <p:nvPr/>
        </p:nvSpPr>
        <p:spPr>
          <a:xfrm>
            <a:off x="568712" y="1073529"/>
            <a:ext cx="57663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unprocessed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original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version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gel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blots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 in Fig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4A</a:t>
            </a:r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de-A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C6E41D2E-7146-4D38-840F-40FD2F431764}"/>
              </a:ext>
            </a:extLst>
          </p:cNvPr>
          <p:cNvSpPr txBox="1"/>
          <p:nvPr/>
        </p:nvSpPr>
        <p:spPr>
          <a:xfrm>
            <a:off x="568712" y="1678481"/>
            <a:ext cx="9220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Wild type</a:t>
            </a:r>
            <a:endParaRPr lang="de-A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D31F5F53-D68C-4143-9683-46BF4758F81D}"/>
              </a:ext>
            </a:extLst>
          </p:cNvPr>
          <p:cNvSpPr txBox="1"/>
          <p:nvPr/>
        </p:nvSpPr>
        <p:spPr>
          <a:xfrm>
            <a:off x="489914" y="5194608"/>
            <a:ext cx="7713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apro1</a:t>
            </a:r>
            <a:r>
              <a:rPr lang="el-GR" sz="14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endParaRPr lang="de-AT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7301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</Words>
  <Application>Microsoft Office PowerPoint</Application>
  <PresentationFormat>A4-Papier (210 x 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osef</dc:creator>
  <cp:lastModifiedBy>Josef</cp:lastModifiedBy>
  <cp:revision>1</cp:revision>
  <cp:lastPrinted>2022-01-30T17:27:50Z</cp:lastPrinted>
  <dcterms:created xsi:type="dcterms:W3CDTF">2022-01-30T17:02:36Z</dcterms:created>
  <dcterms:modified xsi:type="dcterms:W3CDTF">2022-01-30T17:28:22Z</dcterms:modified>
</cp:coreProperties>
</file>